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19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C8614-41CD-4727-B96F-54BA6B5F71D7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2AD3D-5BCF-4623-A028-7286362A29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07043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C8614-41CD-4727-B96F-54BA6B5F71D7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2AD3D-5BCF-4623-A028-7286362A29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9516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C8614-41CD-4727-B96F-54BA6B5F71D7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2AD3D-5BCF-4623-A028-7286362A29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51543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C8614-41CD-4727-B96F-54BA6B5F71D7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2AD3D-5BCF-4623-A028-7286362A29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26038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C8614-41CD-4727-B96F-54BA6B5F71D7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2AD3D-5BCF-4623-A028-7286362A29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73477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C8614-41CD-4727-B96F-54BA6B5F71D7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2AD3D-5BCF-4623-A028-7286362A29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1398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C8614-41CD-4727-B96F-54BA6B5F71D7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2AD3D-5BCF-4623-A028-7286362A29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78747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C8614-41CD-4727-B96F-54BA6B5F71D7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2AD3D-5BCF-4623-A028-7286362A29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91526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C8614-41CD-4727-B96F-54BA6B5F71D7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2AD3D-5BCF-4623-A028-7286362A29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06159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C8614-41CD-4727-B96F-54BA6B5F71D7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2AD3D-5BCF-4623-A028-7286362A29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0399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C8614-41CD-4727-B96F-54BA6B5F71D7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2AD3D-5BCF-4623-A028-7286362A29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37248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9C8614-41CD-4727-B96F-54BA6B5F71D7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52AD3D-5BCF-4623-A028-7286362A29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39724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063" t="40044" r="28172" b="48433"/>
          <a:stretch/>
        </p:blipFill>
        <p:spPr>
          <a:xfrm>
            <a:off x="1735486" y="2994708"/>
            <a:ext cx="4044372" cy="821194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898" t="35724" r="25792" b="39791"/>
          <a:stretch/>
        </p:blipFill>
        <p:spPr>
          <a:xfrm>
            <a:off x="1735491" y="3919078"/>
            <a:ext cx="4044367" cy="175393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047" t="32267" r="29056" b="46129"/>
          <a:stretch/>
        </p:blipFill>
        <p:spPr>
          <a:xfrm>
            <a:off x="1735486" y="1359575"/>
            <a:ext cx="4044367" cy="1531957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658357" y="1467463"/>
            <a:ext cx="530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 smtClean="0">
                <a:solidFill>
                  <a:schemeClr val="bg1"/>
                </a:solidFill>
              </a:rPr>
              <a:t>kDa</a:t>
            </a:r>
            <a:endParaRPr lang="en-US" sz="1400" dirty="0">
              <a:solidFill>
                <a:schemeClr val="bg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794059" y="1756553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794059" y="1938946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solidFill>
                  <a:schemeClr val="bg1"/>
                </a:solidFill>
              </a:rPr>
              <a:t>13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794059" y="2153907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801741" y="2386255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>
                <a:solidFill>
                  <a:schemeClr val="bg1"/>
                </a:solidFill>
              </a:rPr>
              <a:t>7</a:t>
            </a:r>
            <a:r>
              <a:rPr lang="de-DE" sz="1050" dirty="0" smtClean="0">
                <a:solidFill>
                  <a:schemeClr val="bg1"/>
                </a:solidFill>
              </a:rPr>
              <a:t>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809687" y="2999085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solidFill>
                  <a:schemeClr val="bg1"/>
                </a:solidFill>
              </a:rPr>
              <a:t>5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809687" y="3484072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>
                <a:solidFill>
                  <a:schemeClr val="bg1"/>
                </a:solidFill>
              </a:rPr>
              <a:t>3</a:t>
            </a:r>
            <a:r>
              <a:rPr lang="de-DE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809687" y="4172149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801741" y="4857178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>
                <a:solidFill>
                  <a:schemeClr val="bg1"/>
                </a:solidFill>
              </a:rPr>
              <a:t>1</a:t>
            </a:r>
            <a:r>
              <a:rPr lang="de-DE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809687" y="5121836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solidFill>
                  <a:schemeClr val="bg1"/>
                </a:solidFill>
              </a:rPr>
              <a:t>1</a:t>
            </a:r>
            <a:r>
              <a:rPr lang="de-DE" sz="1050" dirty="0">
                <a:solidFill>
                  <a:schemeClr val="bg1"/>
                </a:solidFill>
              </a:rPr>
              <a:t>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99032" y="4279870"/>
            <a:ext cx="8035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/>
              <a:t>IB: GPX4</a:t>
            </a:r>
            <a:endParaRPr lang="en-US" sz="1400" dirty="0"/>
          </a:p>
        </p:txBody>
      </p:sp>
      <p:sp>
        <p:nvSpPr>
          <p:cNvPr id="18" name="TextBox 17"/>
          <p:cNvSpPr txBox="1"/>
          <p:nvPr/>
        </p:nvSpPr>
        <p:spPr>
          <a:xfrm>
            <a:off x="811835" y="3161387"/>
            <a:ext cx="9236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/>
              <a:t>IB: ß-actin</a:t>
            </a:r>
            <a:endParaRPr lang="en-US" sz="1400" dirty="0"/>
          </a:p>
        </p:txBody>
      </p:sp>
      <p:sp>
        <p:nvSpPr>
          <p:cNvPr id="19" name="TextBox 18"/>
          <p:cNvSpPr txBox="1"/>
          <p:nvPr/>
        </p:nvSpPr>
        <p:spPr>
          <a:xfrm>
            <a:off x="799032" y="1971664"/>
            <a:ext cx="7729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/>
              <a:t>IB: LRP8</a:t>
            </a:r>
            <a:endParaRPr lang="en-US" sz="1400" dirty="0"/>
          </a:p>
        </p:txBody>
      </p:sp>
      <p:sp>
        <p:nvSpPr>
          <p:cNvPr id="20" name="Rectangle 19"/>
          <p:cNvSpPr/>
          <p:nvPr/>
        </p:nvSpPr>
        <p:spPr>
          <a:xfrm>
            <a:off x="2379901" y="1979372"/>
            <a:ext cx="2481347" cy="3108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/>
          <p:cNvSpPr/>
          <p:nvPr/>
        </p:nvSpPr>
        <p:spPr>
          <a:xfrm>
            <a:off x="2379901" y="3091456"/>
            <a:ext cx="2481347" cy="3108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2379900" y="4026772"/>
            <a:ext cx="2481347" cy="6665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Box 22"/>
          <p:cNvSpPr txBox="1"/>
          <p:nvPr/>
        </p:nvSpPr>
        <p:spPr>
          <a:xfrm>
            <a:off x="228600" y="237744"/>
            <a:ext cx="10104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2J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6588639" y="6389040"/>
            <a:ext cx="54659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Colorimetric and chemiluminecent signals were merged</a:t>
            </a:r>
            <a:endParaRPr lang="en-US" dirty="0"/>
          </a:p>
        </p:txBody>
      </p:sp>
      <p:sp>
        <p:nvSpPr>
          <p:cNvPr id="25" name="TextBox 24"/>
          <p:cNvSpPr txBox="1"/>
          <p:nvPr/>
        </p:nvSpPr>
        <p:spPr>
          <a:xfrm>
            <a:off x="4763280" y="527835"/>
            <a:ext cx="70278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rgbClr val="FF0000"/>
                </a:solidFill>
              </a:rPr>
              <a:t>Red boxes always indicate the cropped areas ther were used in the figure</a:t>
            </a:r>
          </a:p>
        </p:txBody>
      </p:sp>
    </p:spTree>
    <p:extLst>
      <p:ext uri="{BB962C8B-B14F-4D97-AF65-F5344CB8AC3E}">
        <p14:creationId xmlns:p14="http://schemas.microsoft.com/office/powerpoint/2010/main" val="24988054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662" t="36924" r="33798" b="51250"/>
          <a:stretch/>
        </p:blipFill>
        <p:spPr>
          <a:xfrm>
            <a:off x="4412435" y="3725306"/>
            <a:ext cx="2365132" cy="71217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526" t="40819" r="37427" b="53119"/>
          <a:stretch/>
        </p:blipFill>
        <p:spPr>
          <a:xfrm>
            <a:off x="4430021" y="4537979"/>
            <a:ext cx="2347546" cy="39565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626" t="40955" r="39556" b="53338"/>
          <a:stretch/>
        </p:blipFill>
        <p:spPr>
          <a:xfrm>
            <a:off x="4430021" y="3236460"/>
            <a:ext cx="2347546" cy="38835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CaixaDeTexto 18">
            <a:extLst>
              <a:ext uri="{FF2B5EF4-FFF2-40B4-BE49-F238E27FC236}">
                <a16:creationId xmlns:a16="http://schemas.microsoft.com/office/drawing/2014/main" id="{E98A3A0B-5BF4-2B40-B0C8-9FDF5A9374FF}"/>
              </a:ext>
            </a:extLst>
          </p:cNvPr>
          <p:cNvSpPr txBox="1"/>
          <p:nvPr/>
        </p:nvSpPr>
        <p:spPr>
          <a:xfrm rot="18231420">
            <a:off x="4356615" y="2728056"/>
            <a:ext cx="7649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on-targe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CaixaDeTexto 18">
            <a:extLst>
              <a:ext uri="{FF2B5EF4-FFF2-40B4-BE49-F238E27FC236}">
                <a16:creationId xmlns:a16="http://schemas.microsoft.com/office/drawing/2014/main" id="{E98A3A0B-5BF4-2B40-B0C8-9FDF5A9374FF}"/>
              </a:ext>
            </a:extLst>
          </p:cNvPr>
          <p:cNvSpPr txBox="1"/>
          <p:nvPr/>
        </p:nvSpPr>
        <p:spPr>
          <a:xfrm rot="18231420">
            <a:off x="4525821" y="2658395"/>
            <a:ext cx="1063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RP8g3 KO C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CaixaDeTexto 18">
            <a:extLst>
              <a:ext uri="{FF2B5EF4-FFF2-40B4-BE49-F238E27FC236}">
                <a16:creationId xmlns:a16="http://schemas.microsoft.com/office/drawing/2014/main" id="{E98A3A0B-5BF4-2B40-B0C8-9FDF5A9374FF}"/>
              </a:ext>
            </a:extLst>
          </p:cNvPr>
          <p:cNvSpPr txBox="1"/>
          <p:nvPr/>
        </p:nvSpPr>
        <p:spPr>
          <a:xfrm rot="18231420">
            <a:off x="5167382" y="2727404"/>
            <a:ext cx="7649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on-targe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CaixaDeTexto 18">
            <a:extLst>
              <a:ext uri="{FF2B5EF4-FFF2-40B4-BE49-F238E27FC236}">
                <a16:creationId xmlns:a16="http://schemas.microsoft.com/office/drawing/2014/main" id="{E98A3A0B-5BF4-2B40-B0C8-9FDF5A9374FF}"/>
              </a:ext>
            </a:extLst>
          </p:cNvPr>
          <p:cNvSpPr txBox="1"/>
          <p:nvPr/>
        </p:nvSpPr>
        <p:spPr>
          <a:xfrm rot="18231420">
            <a:off x="5336588" y="2657743"/>
            <a:ext cx="1063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RP8g3 KO C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CaixaDeTexto 18">
            <a:extLst>
              <a:ext uri="{FF2B5EF4-FFF2-40B4-BE49-F238E27FC236}">
                <a16:creationId xmlns:a16="http://schemas.microsoft.com/office/drawing/2014/main" id="{E98A3A0B-5BF4-2B40-B0C8-9FDF5A9374FF}"/>
              </a:ext>
            </a:extLst>
          </p:cNvPr>
          <p:cNvSpPr txBox="1"/>
          <p:nvPr/>
        </p:nvSpPr>
        <p:spPr>
          <a:xfrm rot="18231420">
            <a:off x="5978149" y="2727179"/>
            <a:ext cx="7649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on-targe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CaixaDeTexto 18">
            <a:extLst>
              <a:ext uri="{FF2B5EF4-FFF2-40B4-BE49-F238E27FC236}">
                <a16:creationId xmlns:a16="http://schemas.microsoft.com/office/drawing/2014/main" id="{E98A3A0B-5BF4-2B40-B0C8-9FDF5A9374FF}"/>
              </a:ext>
            </a:extLst>
          </p:cNvPr>
          <p:cNvSpPr txBox="1"/>
          <p:nvPr/>
        </p:nvSpPr>
        <p:spPr>
          <a:xfrm rot="18231420">
            <a:off x="6147355" y="2657518"/>
            <a:ext cx="1063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RP8g3 KO C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Straight Connector 18"/>
          <p:cNvCxnSpPr/>
          <p:nvPr/>
        </p:nvCxnSpPr>
        <p:spPr>
          <a:xfrm>
            <a:off x="4701420" y="2333851"/>
            <a:ext cx="53936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5546388" y="2333851"/>
            <a:ext cx="53936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6388307" y="2333851"/>
            <a:ext cx="53936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3747091" y="3276746"/>
            <a:ext cx="6335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LRP8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5410352" y="1799682"/>
            <a:ext cx="81144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Gpx4 </a:t>
            </a:r>
          </a:p>
          <a:p>
            <a:pPr algn="ctr"/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6243896" y="1805724"/>
            <a:ext cx="81144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Gpx4 </a:t>
            </a:r>
          </a:p>
          <a:p>
            <a:pPr algn="ctr"/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U46C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4686726" y="2021434"/>
            <a:ext cx="6126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723377" y="3927506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PX4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6862338" y="3725306"/>
            <a:ext cx="10310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SH-Gpx4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6874841" y="4081394"/>
            <a:ext cx="11897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ndogenous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682909" y="4581917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ß-actin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04119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62</Words>
  <Application>Microsoft Office PowerPoint</Application>
  <PresentationFormat>Widescreen</PresentationFormat>
  <Paragraphs>3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Julius-Maximilians-Universität Würz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iyi Chen</dc:creator>
  <cp:lastModifiedBy>Zhiyi Chen</cp:lastModifiedBy>
  <cp:revision>3</cp:revision>
  <dcterms:created xsi:type="dcterms:W3CDTF">2022-09-26T07:57:26Z</dcterms:created>
  <dcterms:modified xsi:type="dcterms:W3CDTF">2023-05-30T13:58:21Z</dcterms:modified>
</cp:coreProperties>
</file>